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9"/>
  </p:notesMasterIdLst>
  <p:sldIdLst>
    <p:sldId id="256" r:id="rId2"/>
    <p:sldId id="263" r:id="rId3"/>
    <p:sldId id="257" r:id="rId4"/>
    <p:sldId id="258" r:id="rId5"/>
    <p:sldId id="259" r:id="rId6"/>
    <p:sldId id="260" r:id="rId7"/>
    <p:sldId id="261" r:id="rId8"/>
  </p:sldIdLst>
  <p:sldSz cx="6858000" cy="9906000" type="A4"/>
  <p:notesSz cx="6669088" cy="9926638"/>
  <p:embeddedFontLst>
    <p:embeddedFont>
      <p:font typeface="Calibri" panose="020F0502020204030204" pitchFamily="34" charset="0"/>
      <p:regular r:id="rId10"/>
      <p:bold r:id="rId11"/>
      <p:italic r:id="rId12"/>
      <p:boldItalic r:id="rId13"/>
    </p:embeddedFont>
    <p:embeddedFont>
      <p:font typeface="Noto Sans Symbols" panose="020B0604020202020204" charset="0"/>
      <p:regular r:id="rId14"/>
      <p:bold r:id="rId15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22" roundtripDataSignature="AMtx7mh1zcRgudhfPsnd/haEx6um3GAJe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80" d="100"/>
          <a:sy n="80" d="100"/>
        </p:scale>
        <p:origin x="2030" y="-2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355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font" Target="fonts/font4.fntdata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font" Target="fonts/font3.fntdata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font" Target="fonts/font2.fntdata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font" Target="fonts/font6.fntdata"/><Relationship Id="rId23" Type="http://schemas.openxmlformats.org/officeDocument/2006/relationships/presProps" Target="presProps.xml"/><Relationship Id="rId10" Type="http://schemas.openxmlformats.org/officeDocument/2006/relationships/font" Target="fonts/font1.fntdata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font" Target="fonts/font5.fntdata"/><Relationship Id="rId22" Type="http://customschemas.google.com/relationships/presentationmetadata" Target="meta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11725" y="744475"/>
            <a:ext cx="4446250" cy="372247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66900" y="4715125"/>
            <a:ext cx="5335250" cy="44669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Google Shape;160;p1:notes"/>
          <p:cNvSpPr txBox="1">
            <a:spLocks noGrp="1"/>
          </p:cNvSpPr>
          <p:nvPr>
            <p:ph type="body" idx="1"/>
          </p:nvPr>
        </p:nvSpPr>
        <p:spPr>
          <a:xfrm>
            <a:off x="666900" y="4715125"/>
            <a:ext cx="5335250" cy="4466975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61" name="Google Shape;161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46288" y="744538"/>
            <a:ext cx="2576512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Google Shape;234;g21f7978038c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46288" y="744538"/>
            <a:ext cx="2576512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35" name="Google Shape;235;g21f7978038c_0_0:notes"/>
          <p:cNvSpPr txBox="1">
            <a:spLocks noGrp="1"/>
          </p:cNvSpPr>
          <p:nvPr>
            <p:ph type="body" idx="1"/>
          </p:nvPr>
        </p:nvSpPr>
        <p:spPr>
          <a:xfrm>
            <a:off x="666900" y="4715125"/>
            <a:ext cx="5335200" cy="4467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Google Shape;168;p2:notes"/>
          <p:cNvSpPr txBox="1">
            <a:spLocks noGrp="1"/>
          </p:cNvSpPr>
          <p:nvPr>
            <p:ph type="body" idx="1"/>
          </p:nvPr>
        </p:nvSpPr>
        <p:spPr>
          <a:xfrm>
            <a:off x="666900" y="4715125"/>
            <a:ext cx="5335250" cy="4466975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69" name="Google Shape;169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46288" y="744538"/>
            <a:ext cx="2576512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Google Shape;185;p3:notes"/>
          <p:cNvSpPr txBox="1">
            <a:spLocks noGrp="1"/>
          </p:cNvSpPr>
          <p:nvPr>
            <p:ph type="body" idx="1"/>
          </p:nvPr>
        </p:nvSpPr>
        <p:spPr>
          <a:xfrm>
            <a:off x="666900" y="4715125"/>
            <a:ext cx="5335250" cy="4466975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86" name="Google Shape;186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46288" y="744538"/>
            <a:ext cx="2576512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6" name="Google Shape;196;p4:notes"/>
          <p:cNvSpPr txBox="1">
            <a:spLocks noGrp="1"/>
          </p:cNvSpPr>
          <p:nvPr>
            <p:ph type="body" idx="1"/>
          </p:nvPr>
        </p:nvSpPr>
        <p:spPr>
          <a:xfrm>
            <a:off x="666900" y="4715125"/>
            <a:ext cx="5335250" cy="4466975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97" name="Google Shape;197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46288" y="744538"/>
            <a:ext cx="2576512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" name="Google Shape;207;p5:notes"/>
          <p:cNvSpPr txBox="1">
            <a:spLocks noGrp="1"/>
          </p:cNvSpPr>
          <p:nvPr>
            <p:ph type="body" idx="1"/>
          </p:nvPr>
        </p:nvSpPr>
        <p:spPr>
          <a:xfrm>
            <a:off x="666900" y="4715125"/>
            <a:ext cx="5335250" cy="4466975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08" name="Google Shape;208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46288" y="744538"/>
            <a:ext cx="2576512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Google Shape;218;p6:notes"/>
          <p:cNvSpPr txBox="1">
            <a:spLocks noGrp="1"/>
          </p:cNvSpPr>
          <p:nvPr>
            <p:ph type="body" idx="1"/>
          </p:nvPr>
        </p:nvSpPr>
        <p:spPr>
          <a:xfrm>
            <a:off x="666900" y="4715125"/>
            <a:ext cx="5335250" cy="4466975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219" name="Google Shape;219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46288" y="744538"/>
            <a:ext cx="2576512" cy="3722687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olo e contenuto" type="obj">
  <p:cSld name="OBJECT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8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8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4" name="Google Shape;14;p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magine con didascalia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7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7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7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1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olo e testo verticale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8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8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1_Titolo e testo verticale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9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9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a titolo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9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9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20" name="Google Shape;20;p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" type="tx">
  <p:cSld name="TITLE_AND_BODY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10"/>
          <p:cNvSpPr txBox="1">
            <a:spLocks noGrp="1"/>
          </p:cNvSpPr>
          <p:nvPr>
            <p:ph type="title"/>
          </p:nvPr>
        </p:nvSpPr>
        <p:spPr>
          <a:xfrm>
            <a:off x="233781" y="1433997"/>
            <a:ext cx="6390450" cy="39531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43775" tIns="243775" rIns="243775" bIns="243775" anchor="b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882"/>
              <a:buFont typeface="Arial"/>
              <a:buNone/>
              <a:defRPr sz="3882" b="0"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0"/>
          <p:cNvSpPr txBox="1">
            <a:spLocks noGrp="1"/>
          </p:cNvSpPr>
          <p:nvPr>
            <p:ph type="body" idx="1"/>
          </p:nvPr>
        </p:nvSpPr>
        <p:spPr>
          <a:xfrm>
            <a:off x="233775" y="5458315"/>
            <a:ext cx="6390451" cy="15264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43775" tIns="243775" rIns="243775" bIns="243775" anchor="t" anchorCtr="0">
            <a:normAutofit/>
          </a:bodyPr>
          <a:lstStyle>
            <a:lvl1pPr marL="457200" lvl="0" indent="-22860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595959"/>
              </a:buClr>
              <a:buSzPts val="2082"/>
              <a:buNone/>
              <a:defRPr sz="2082">
                <a:solidFill>
                  <a:srgbClr val="595959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lvl="1" indent="-22860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595959"/>
              </a:buClr>
              <a:buSzPts val="2082"/>
              <a:buNone/>
              <a:defRPr sz="2082">
                <a:solidFill>
                  <a:srgbClr val="595959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lvl="2" indent="-22860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595959"/>
              </a:buClr>
              <a:buSzPts val="2082"/>
              <a:buNone/>
              <a:defRPr sz="2082">
                <a:solidFill>
                  <a:srgbClr val="595959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lvl="3" indent="-22860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595959"/>
              </a:buClr>
              <a:buSzPts val="2082"/>
              <a:buNone/>
              <a:defRPr sz="2082">
                <a:solidFill>
                  <a:srgbClr val="595959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lvl="4" indent="-22860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595959"/>
              </a:buClr>
              <a:buSzPts val="2082"/>
              <a:buNone/>
              <a:defRPr sz="2082">
                <a:solidFill>
                  <a:srgbClr val="595959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6" name="Google Shape;26;p10"/>
          <p:cNvSpPr txBox="1">
            <a:spLocks noGrp="1"/>
          </p:cNvSpPr>
          <p:nvPr>
            <p:ph type="sldNum" idx="12"/>
          </p:nvPr>
        </p:nvSpPr>
        <p:spPr>
          <a:xfrm>
            <a:off x="6521861" y="9045686"/>
            <a:ext cx="244008" cy="62869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43775" tIns="243775" rIns="243775" bIns="243775" anchor="ctr" anchorCtr="0">
            <a:normAutofit/>
          </a:bodyPr>
          <a:lstStyle>
            <a:lvl1pPr marL="0" lvl="0" indent="0" algn="r">
              <a:spcBef>
                <a:spcPts val="0"/>
              </a:spcBef>
              <a:buNone/>
              <a:defRPr sz="731">
                <a:solidFill>
                  <a:srgbClr val="595959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lvl="1" indent="0" algn="r">
              <a:spcBef>
                <a:spcPts val="0"/>
              </a:spcBef>
              <a:buNone/>
              <a:defRPr sz="731">
                <a:solidFill>
                  <a:srgbClr val="595959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lvl="2" indent="0" algn="r">
              <a:spcBef>
                <a:spcPts val="0"/>
              </a:spcBef>
              <a:buNone/>
              <a:defRPr sz="731">
                <a:solidFill>
                  <a:srgbClr val="595959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lvl="3" indent="0" algn="r">
              <a:spcBef>
                <a:spcPts val="0"/>
              </a:spcBef>
              <a:buNone/>
              <a:defRPr sz="731">
                <a:solidFill>
                  <a:srgbClr val="595959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lvl="4" indent="0" algn="r">
              <a:spcBef>
                <a:spcPts val="0"/>
              </a:spcBef>
              <a:buNone/>
              <a:defRPr sz="731">
                <a:solidFill>
                  <a:srgbClr val="595959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lvl="5" indent="0" algn="r">
              <a:spcBef>
                <a:spcPts val="0"/>
              </a:spcBef>
              <a:buNone/>
              <a:defRPr sz="731">
                <a:solidFill>
                  <a:srgbClr val="595959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lvl="6" indent="0" algn="r">
              <a:spcBef>
                <a:spcPts val="0"/>
              </a:spcBef>
              <a:buNone/>
              <a:defRPr sz="731">
                <a:solidFill>
                  <a:srgbClr val="595959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lvl="7" indent="0" algn="r">
              <a:spcBef>
                <a:spcPts val="0"/>
              </a:spcBef>
              <a:buNone/>
              <a:defRPr sz="731">
                <a:solidFill>
                  <a:srgbClr val="595959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lvl="8" indent="0" algn="r">
              <a:spcBef>
                <a:spcPts val="0"/>
              </a:spcBef>
              <a:buNone/>
              <a:defRPr sz="731">
                <a:solidFill>
                  <a:srgbClr val="595959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ntestazione sezione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1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1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1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ue contenuti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2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2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2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fronto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3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3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13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3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13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lo titolo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4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uota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to con didascalia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6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6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16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1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7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7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N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EE540F81-B91C-3823-8122-ED79A47C837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6835" r="71790" b="47663"/>
          <a:stretch/>
        </p:blipFill>
        <p:spPr>
          <a:xfrm>
            <a:off x="663021" y="22860"/>
            <a:ext cx="4968160" cy="3516918"/>
          </a:xfrm>
          <a:prstGeom prst="rect">
            <a:avLst/>
          </a:prstGeom>
        </p:spPr>
      </p:pic>
      <p:pic>
        <p:nvPicPr>
          <p:cNvPr id="4" name="Immagine 3">
            <a:extLst>
              <a:ext uri="{FF2B5EF4-FFF2-40B4-BE49-F238E27FC236}">
                <a16:creationId xmlns:a16="http://schemas.microsoft.com/office/drawing/2014/main" id="{2DB9326D-2E84-10A8-93FD-269384F9D77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0078" t="12383" r="36971" b="49761"/>
          <a:stretch/>
        </p:blipFill>
        <p:spPr>
          <a:xfrm>
            <a:off x="781048" y="3356899"/>
            <a:ext cx="5086352" cy="3286966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2991A856-44BE-77CF-90B5-D1034367936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3187" t="12974" b="48824"/>
          <a:stretch/>
        </p:blipFill>
        <p:spPr>
          <a:xfrm>
            <a:off x="800065" y="6667500"/>
            <a:ext cx="4922555" cy="2873466"/>
          </a:xfrm>
          <a:prstGeom prst="rect">
            <a:avLst/>
          </a:prstGeom>
        </p:spPr>
      </p:pic>
      <p:sp>
        <p:nvSpPr>
          <p:cNvPr id="166" name="Google Shape;166;p1"/>
          <p:cNvSpPr txBox="1"/>
          <p:nvPr/>
        </p:nvSpPr>
        <p:spPr>
          <a:xfrm>
            <a:off x="0" y="9485116"/>
            <a:ext cx="6825523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 S1. </a:t>
            </a:r>
            <a:r>
              <a:rPr lang="it-IT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ifferential</a:t>
            </a:r>
            <a:r>
              <a:rPr lang="it-IT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it-IT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evels</a:t>
            </a:r>
            <a:r>
              <a:rPr lang="it-IT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of </a:t>
            </a:r>
            <a:r>
              <a:rPr lang="it-IT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zonulin</a:t>
            </a:r>
            <a:r>
              <a:rPr lang="it-IT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(p=0.595) (panel A);  PV-1 (p=0.322) (panel B); and citrulline (p&lt;0.001) (panel C)  </a:t>
            </a:r>
            <a:r>
              <a:rPr lang="it-IT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t</a:t>
            </a:r>
            <a:r>
              <a:rPr lang="it-IT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T</a:t>
            </a:r>
            <a:r>
              <a:rPr lang="it-IT" sz="1200" b="0" i="0" u="none" strike="noStrike" cap="none" baseline="-25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r>
              <a:rPr lang="it-IT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nd T</a:t>
            </a:r>
            <a:r>
              <a:rPr lang="it-IT" sz="1200" b="0" i="0" u="none" strike="noStrike" cap="none" baseline="-25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</a:t>
            </a:r>
            <a:r>
              <a:rPr lang="it-IT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, </a:t>
            </a:r>
            <a:r>
              <a:rPr lang="it-IT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espectively</a:t>
            </a:r>
            <a:endParaRPr sz="1200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B0323313-B9FE-D531-3C99-4B0B6125EB6A}"/>
              </a:ext>
            </a:extLst>
          </p:cNvPr>
          <p:cNvSpPr txBox="1"/>
          <p:nvPr/>
        </p:nvSpPr>
        <p:spPr>
          <a:xfrm>
            <a:off x="815907" y="9906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000" b="1" dirty="0"/>
              <a:t>A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FADA8C36-50F1-EBDB-0080-6B29B02A64F2}"/>
              </a:ext>
            </a:extLst>
          </p:cNvPr>
          <p:cNvSpPr txBox="1"/>
          <p:nvPr/>
        </p:nvSpPr>
        <p:spPr>
          <a:xfrm>
            <a:off x="866707" y="340360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000" b="1" dirty="0"/>
              <a:t>B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44E65587-610D-53A1-8DCB-87AE5BFC87B1}"/>
              </a:ext>
            </a:extLst>
          </p:cNvPr>
          <p:cNvSpPr txBox="1"/>
          <p:nvPr/>
        </p:nvSpPr>
        <p:spPr>
          <a:xfrm>
            <a:off x="828607" y="668274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000" b="1" dirty="0"/>
              <a:t>C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Google Shape;237;g21f7978038c_0_0"/>
          <p:cNvSpPr txBox="1">
            <a:spLocks noGrp="1"/>
          </p:cNvSpPr>
          <p:nvPr>
            <p:ph type="subTitle" idx="1"/>
          </p:nvPr>
        </p:nvSpPr>
        <p:spPr>
          <a:xfrm>
            <a:off x="303530" y="4884777"/>
            <a:ext cx="6066790" cy="736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just" rtl="0">
              <a:spcBef>
                <a:spcPts val="750"/>
              </a:spcBef>
              <a:spcAft>
                <a:spcPts val="0"/>
              </a:spcAft>
              <a:buNone/>
            </a:pPr>
            <a:r>
              <a:rPr lang="it-IT" sz="1200" b="1" dirty="0">
                <a:latin typeface="+mj-lt"/>
                <a:ea typeface="Palatino Linotype"/>
                <a:cs typeface="Palatino Linotype"/>
                <a:sym typeface="Palatino Linotype"/>
              </a:rPr>
              <a:t>Figure S2</a:t>
            </a:r>
            <a:r>
              <a:rPr lang="it-IT" sz="1200" dirty="0">
                <a:latin typeface="+mj-lt"/>
                <a:ea typeface="Palatino Linotype"/>
                <a:cs typeface="Palatino Linotype"/>
                <a:sym typeface="Palatino Linotype"/>
              </a:rPr>
              <a:t>. Evaluation of </a:t>
            </a:r>
            <a:r>
              <a:rPr lang="it-IT" sz="1200" dirty="0" err="1">
                <a:latin typeface="+mj-lt"/>
                <a:ea typeface="Palatino Linotype"/>
                <a:cs typeface="Palatino Linotype"/>
                <a:sym typeface="Palatino Linotype"/>
              </a:rPr>
              <a:t>dominance</a:t>
            </a:r>
            <a:r>
              <a:rPr lang="it-IT" sz="1200" dirty="0">
                <a:latin typeface="+mj-lt"/>
                <a:ea typeface="Palatino Linotype"/>
                <a:cs typeface="Palatino Linotype"/>
                <a:sym typeface="Palatino Linotype"/>
              </a:rPr>
              <a:t> index for T</a:t>
            </a:r>
            <a:r>
              <a:rPr lang="it-IT" sz="1200" baseline="-25000" dirty="0">
                <a:latin typeface="+mj-lt"/>
                <a:ea typeface="Palatino Linotype"/>
                <a:cs typeface="Palatino Linotype"/>
                <a:sym typeface="Palatino Linotype"/>
              </a:rPr>
              <a:t>0</a:t>
            </a:r>
            <a:r>
              <a:rPr lang="it-IT" sz="1200" dirty="0">
                <a:latin typeface="+mj-lt"/>
                <a:ea typeface="Palatino Linotype"/>
                <a:cs typeface="Palatino Linotype"/>
                <a:sym typeface="Palatino Linotype"/>
              </a:rPr>
              <a:t> and T</a:t>
            </a:r>
            <a:r>
              <a:rPr lang="it-IT" sz="1200" baseline="-25000" dirty="0">
                <a:latin typeface="+mj-lt"/>
                <a:ea typeface="Palatino Linotype"/>
                <a:cs typeface="Palatino Linotype"/>
                <a:sym typeface="Palatino Linotype"/>
              </a:rPr>
              <a:t>1</a:t>
            </a:r>
            <a:r>
              <a:rPr lang="it-IT" sz="1200" dirty="0">
                <a:latin typeface="+mj-lt"/>
                <a:ea typeface="Palatino Linotype"/>
                <a:cs typeface="Palatino Linotype"/>
                <a:sym typeface="Palatino Linotype"/>
              </a:rPr>
              <a:t> time-point, </a:t>
            </a:r>
            <a:r>
              <a:rPr lang="it-IT" sz="1200" dirty="0" err="1">
                <a:latin typeface="+mj-lt"/>
                <a:ea typeface="Palatino Linotype"/>
                <a:cs typeface="Palatino Linotype"/>
                <a:sym typeface="Palatino Linotype"/>
              </a:rPr>
              <a:t>pre</a:t>
            </a:r>
            <a:r>
              <a:rPr lang="it-IT" sz="1200" dirty="0">
                <a:latin typeface="+mj-lt"/>
                <a:ea typeface="Palatino Linotype"/>
                <a:cs typeface="Palatino Linotype"/>
                <a:sym typeface="Palatino Linotype"/>
              </a:rPr>
              <a:t> and post </a:t>
            </a:r>
            <a:r>
              <a:rPr lang="it-IT" sz="1200" dirty="0" err="1">
                <a:latin typeface="+mj-lt"/>
                <a:ea typeface="Palatino Linotype"/>
                <a:cs typeface="Palatino Linotype"/>
                <a:sym typeface="Palatino Linotype"/>
              </a:rPr>
              <a:t>probiotic</a:t>
            </a:r>
            <a:r>
              <a:rPr lang="it-IT" sz="1200" dirty="0">
                <a:latin typeface="+mj-lt"/>
                <a:ea typeface="Palatino Linotype"/>
                <a:cs typeface="Palatino Linotype"/>
                <a:sym typeface="Palatino Linotype"/>
              </a:rPr>
              <a:t> </a:t>
            </a:r>
            <a:r>
              <a:rPr lang="it-IT" sz="1200" dirty="0" err="1">
                <a:latin typeface="+mj-lt"/>
                <a:ea typeface="Palatino Linotype"/>
                <a:cs typeface="Palatino Linotype"/>
                <a:sym typeface="Palatino Linotype"/>
              </a:rPr>
              <a:t>supplementation</a:t>
            </a:r>
            <a:endParaRPr sz="1200" dirty="0">
              <a:latin typeface="+mj-lt"/>
              <a:ea typeface="Palatino Linotype"/>
              <a:cs typeface="Palatino Linotype"/>
              <a:sym typeface="Palatino Linotype"/>
            </a:endParaRPr>
          </a:p>
        </p:txBody>
      </p:sp>
      <p:pic>
        <p:nvPicPr>
          <p:cNvPr id="238" name="Google Shape;238;g21f7978038c_0_0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638375" y="709525"/>
            <a:ext cx="5362376" cy="357489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Google Shape;171;p2"/>
          <p:cNvSpPr txBox="1"/>
          <p:nvPr/>
        </p:nvSpPr>
        <p:spPr>
          <a:xfrm>
            <a:off x="-53027" y="8734017"/>
            <a:ext cx="6906900" cy="11695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 S3. </a:t>
            </a:r>
            <a:r>
              <a:rPr lang="it-IT" dirty="0">
                <a:solidFill>
                  <a:schemeClr val="dk1"/>
                </a:solidFill>
                <a:latin typeface="Noto Sans Symbols"/>
                <a:ea typeface="Noto Sans Symbols"/>
                <a:cs typeface="Noto Sans Symbols"/>
                <a:sym typeface="Noto Sans Symbols"/>
              </a:rPr>
              <a:t>A)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A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lots of T</a:t>
            </a:r>
            <a:r>
              <a:rPr lang="it-IT" baseline="-25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0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and T</a:t>
            </a:r>
            <a:r>
              <a:rPr lang="it-IT" baseline="-25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time-points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ased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n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rayCurtis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atrices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it-IT" dirty="0">
                <a:solidFill>
                  <a:schemeClr val="dk1"/>
                </a:solidFill>
                <a:latin typeface="Noto Sans Symbols"/>
                <a:ea typeface="Noto Sans Symbols"/>
                <a:cs typeface="Noto Sans Symbols"/>
                <a:sym typeface="Noto Sans Symbols"/>
              </a:rPr>
              <a:t>B)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CoA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lots of T0 and T1 groups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ased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n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uclidean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istances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atrices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C)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CoA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lots of T</a:t>
            </a:r>
            <a:r>
              <a:rPr lang="it-IT" baseline="-25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0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and T</a:t>
            </a:r>
            <a:r>
              <a:rPr lang="it-IT" baseline="-25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time-points 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ased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n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Unweighted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Unifrac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atrices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it-IT" dirty="0">
                <a:solidFill>
                  <a:schemeClr val="dk1"/>
                </a:solidFill>
                <a:latin typeface="Noto Sans Symbols"/>
                <a:ea typeface="Noto Sans Symbols"/>
                <a:cs typeface="Noto Sans Symbols"/>
                <a:sym typeface="Noto Sans Symbols"/>
              </a:rPr>
              <a:t>D)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CoA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lots of T</a:t>
            </a:r>
            <a:r>
              <a:rPr lang="it-IT" baseline="-25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0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and T</a:t>
            </a:r>
            <a:r>
              <a:rPr lang="it-IT" baseline="-25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time-points 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ased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n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eighted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Unifrac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en-US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tatistical analysis was assessed by PERMANOVA test between microbial communities at T</a:t>
            </a:r>
            <a:r>
              <a:rPr lang="en-US" baseline="-25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0</a:t>
            </a:r>
            <a:r>
              <a:rPr lang="en-US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and T</a:t>
            </a:r>
            <a:r>
              <a:rPr lang="en-US" baseline="-25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r>
              <a:rPr lang="en-US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time points (p&gt; 0.05)</a:t>
            </a:r>
            <a:endParaRPr sz="1400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72" name="Google Shape;172;p2"/>
          <p:cNvPicPr preferRelativeResize="0"/>
          <p:nvPr/>
        </p:nvPicPr>
        <p:blipFill rotWithShape="1">
          <a:blip r:embed="rId3">
            <a:alphaModFix/>
          </a:blip>
          <a:srcRect l="5831" t="11163" r="8355" b="5810"/>
          <a:stretch/>
        </p:blipFill>
        <p:spPr>
          <a:xfrm>
            <a:off x="-1271" y="-1"/>
            <a:ext cx="3521700" cy="2868706"/>
          </a:xfrm>
          <a:prstGeom prst="rect">
            <a:avLst/>
          </a:prstGeom>
          <a:noFill/>
          <a:ln>
            <a:noFill/>
          </a:ln>
        </p:spPr>
      </p:pic>
      <p:sp>
        <p:nvSpPr>
          <p:cNvPr id="173" name="Google Shape;173;p2"/>
          <p:cNvSpPr txBox="1"/>
          <p:nvPr/>
        </p:nvSpPr>
        <p:spPr>
          <a:xfrm>
            <a:off x="2618362" y="2421532"/>
            <a:ext cx="825867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ray-Curtis</a:t>
            </a:r>
            <a:endParaRPr dirty="0"/>
          </a:p>
        </p:txBody>
      </p:sp>
      <p:sp>
        <p:nvSpPr>
          <p:cNvPr id="174" name="Google Shape;174;p2"/>
          <p:cNvSpPr txBox="1"/>
          <p:nvPr/>
        </p:nvSpPr>
        <p:spPr>
          <a:xfrm>
            <a:off x="-27717" y="25071"/>
            <a:ext cx="28725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 dirty="0"/>
          </a:p>
        </p:txBody>
      </p:sp>
      <p:pic>
        <p:nvPicPr>
          <p:cNvPr id="175" name="Google Shape;175;p2"/>
          <p:cNvPicPr preferRelativeResize="0"/>
          <p:nvPr/>
        </p:nvPicPr>
        <p:blipFill rotWithShape="1">
          <a:blip r:embed="rId4">
            <a:alphaModFix/>
          </a:blip>
          <a:srcRect l="5833" t="11478" r="9027" b="5703"/>
          <a:stretch/>
        </p:blipFill>
        <p:spPr>
          <a:xfrm>
            <a:off x="3592918" y="53337"/>
            <a:ext cx="3257462" cy="2812041"/>
          </a:xfrm>
          <a:prstGeom prst="rect">
            <a:avLst/>
          </a:prstGeom>
          <a:noFill/>
          <a:ln>
            <a:noFill/>
          </a:ln>
        </p:spPr>
      </p:pic>
      <p:sp>
        <p:nvSpPr>
          <p:cNvPr id="176" name="Google Shape;176;p2"/>
          <p:cNvSpPr txBox="1"/>
          <p:nvPr/>
        </p:nvSpPr>
        <p:spPr>
          <a:xfrm>
            <a:off x="6043488" y="2428555"/>
            <a:ext cx="744114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0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uclidean</a:t>
            </a:r>
            <a:endParaRPr sz="1000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7" name="Google Shape;177;p2"/>
          <p:cNvSpPr txBox="1"/>
          <p:nvPr/>
        </p:nvSpPr>
        <p:spPr>
          <a:xfrm>
            <a:off x="3508378" y="34596"/>
            <a:ext cx="28725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dirty="0"/>
          </a:p>
        </p:txBody>
      </p:sp>
      <p:pic>
        <p:nvPicPr>
          <p:cNvPr id="178" name="Google Shape;178;p2"/>
          <p:cNvPicPr preferRelativeResize="0"/>
          <p:nvPr/>
        </p:nvPicPr>
        <p:blipFill rotWithShape="1">
          <a:blip r:embed="rId5">
            <a:alphaModFix/>
          </a:blip>
          <a:srcRect l="6250" t="10080" r="8355" b="5703"/>
          <a:stretch/>
        </p:blipFill>
        <p:spPr>
          <a:xfrm>
            <a:off x="23615" y="3517091"/>
            <a:ext cx="3445599" cy="2831660"/>
          </a:xfrm>
          <a:prstGeom prst="rect">
            <a:avLst/>
          </a:prstGeom>
          <a:noFill/>
          <a:ln>
            <a:noFill/>
          </a:ln>
        </p:spPr>
      </p:pic>
      <p:sp>
        <p:nvSpPr>
          <p:cNvPr id="179" name="Google Shape;179;p2"/>
          <p:cNvSpPr txBox="1"/>
          <p:nvPr/>
        </p:nvSpPr>
        <p:spPr>
          <a:xfrm>
            <a:off x="2042161" y="5924521"/>
            <a:ext cx="1356359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0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Unweighted</a:t>
            </a:r>
            <a:r>
              <a:rPr lang="it-IT" sz="1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it-IT" sz="10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Unifrac</a:t>
            </a:r>
            <a:r>
              <a:rPr lang="it-IT" sz="1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endParaRPr dirty="0"/>
          </a:p>
        </p:txBody>
      </p:sp>
      <p:sp>
        <p:nvSpPr>
          <p:cNvPr id="180" name="Google Shape;180;p2"/>
          <p:cNvSpPr txBox="1"/>
          <p:nvPr/>
        </p:nvSpPr>
        <p:spPr>
          <a:xfrm>
            <a:off x="3377" y="3569232"/>
            <a:ext cx="295274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 dirty="0"/>
          </a:p>
        </p:txBody>
      </p:sp>
      <p:pic>
        <p:nvPicPr>
          <p:cNvPr id="181" name="Google Shape;181;p2"/>
          <p:cNvPicPr preferRelativeResize="0"/>
          <p:nvPr/>
        </p:nvPicPr>
        <p:blipFill rotWithShape="1">
          <a:blip r:embed="rId6">
            <a:alphaModFix/>
          </a:blip>
          <a:srcRect l="5833" t="10991" r="8472" b="5704"/>
          <a:stretch/>
        </p:blipFill>
        <p:spPr>
          <a:xfrm>
            <a:off x="3493274" y="3550334"/>
            <a:ext cx="3335007" cy="2798417"/>
          </a:xfrm>
          <a:prstGeom prst="rect">
            <a:avLst/>
          </a:prstGeom>
          <a:noFill/>
          <a:ln>
            <a:noFill/>
          </a:ln>
        </p:spPr>
      </p:pic>
      <p:sp>
        <p:nvSpPr>
          <p:cNvPr id="182" name="Google Shape;182;p2"/>
          <p:cNvSpPr txBox="1"/>
          <p:nvPr/>
        </p:nvSpPr>
        <p:spPr>
          <a:xfrm>
            <a:off x="5348486" y="5910925"/>
            <a:ext cx="1411215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0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Weighted</a:t>
            </a:r>
            <a:r>
              <a:rPr lang="it-IT" sz="1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it-IT" sz="10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Unifrac</a:t>
            </a:r>
            <a:r>
              <a:rPr lang="it-IT" sz="1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endParaRPr dirty="0"/>
          </a:p>
        </p:txBody>
      </p:sp>
      <p:sp>
        <p:nvSpPr>
          <p:cNvPr id="183" name="Google Shape;183;p2"/>
          <p:cNvSpPr txBox="1"/>
          <p:nvPr/>
        </p:nvSpPr>
        <p:spPr>
          <a:xfrm>
            <a:off x="3459250" y="3590448"/>
            <a:ext cx="295274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</a:t>
            </a:r>
            <a:endParaRPr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8" name="Google Shape;188;p3" descr="TO_T1_l2.png_legend.png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81641" y="6772055"/>
            <a:ext cx="3300215" cy="1465655"/>
          </a:xfrm>
          <a:prstGeom prst="rect">
            <a:avLst/>
          </a:prstGeom>
          <a:noFill/>
          <a:ln>
            <a:noFill/>
          </a:ln>
        </p:spPr>
      </p:pic>
      <p:sp>
        <p:nvSpPr>
          <p:cNvPr id="189" name="Google Shape;189;p3"/>
          <p:cNvSpPr txBox="1"/>
          <p:nvPr/>
        </p:nvSpPr>
        <p:spPr>
          <a:xfrm>
            <a:off x="-48903" y="9167377"/>
            <a:ext cx="6906903" cy="7386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4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S4.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ifferential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upled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istribution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f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SVs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t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T</a:t>
            </a:r>
            <a:r>
              <a:rPr lang="it-IT" sz="1400" baseline="-25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0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and T</a:t>
            </a:r>
            <a:r>
              <a:rPr lang="it-IT" sz="1400" baseline="-25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time-points for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ach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sample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t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evel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L2 (Phylum) . The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mparison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ased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n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Kruskal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-Wallis are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ot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tatistically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ignificant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(p&gt;0.05)</a:t>
            </a:r>
            <a:endParaRPr sz="14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90" name="Google Shape;190;p3"/>
          <p:cNvGrpSpPr/>
          <p:nvPr/>
        </p:nvGrpSpPr>
        <p:grpSpPr>
          <a:xfrm>
            <a:off x="443373" y="1596647"/>
            <a:ext cx="6354880" cy="4448415"/>
            <a:chOff x="59498" y="1327992"/>
            <a:chExt cx="6739003" cy="4717301"/>
          </a:xfrm>
        </p:grpSpPr>
        <p:pic>
          <p:nvPicPr>
            <p:cNvPr id="191" name="Google Shape;191;p3" descr="TO_T1_l2.png.png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59498" y="1327992"/>
              <a:ext cx="6739003" cy="4717301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92" name="Google Shape;192;p3"/>
            <p:cNvSpPr/>
            <p:nvPr/>
          </p:nvSpPr>
          <p:spPr>
            <a:xfrm>
              <a:off x="6037545" y="3686642"/>
              <a:ext cx="760956" cy="1975122"/>
            </a:xfrm>
            <a:prstGeom prst="rect">
              <a:avLst/>
            </a:prstGeom>
            <a:solidFill>
              <a:schemeClr val="lt1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sp>
        <p:nvSpPr>
          <p:cNvPr id="193" name="Google Shape;193;p3"/>
          <p:cNvSpPr txBox="1"/>
          <p:nvPr/>
        </p:nvSpPr>
        <p:spPr>
          <a:xfrm rot="-5400000">
            <a:off x="-1125900" y="1636100"/>
            <a:ext cx="3000000" cy="384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3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lative Abundances</a:t>
            </a:r>
            <a:endParaRPr sz="1100"/>
          </a:p>
        </p:txBody>
      </p:sp>
      <p:sp>
        <p:nvSpPr>
          <p:cNvPr id="194" name="Google Shape;194;p3"/>
          <p:cNvSpPr txBox="1"/>
          <p:nvPr/>
        </p:nvSpPr>
        <p:spPr>
          <a:xfrm rot="-5400000">
            <a:off x="-1125900" y="3830600"/>
            <a:ext cx="3000000" cy="384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3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lative Abundances</a:t>
            </a:r>
            <a:endParaRPr sz="110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9" name="Google Shape;199;p4" descr="TO_T1_l5.png_legend.png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66801" y="5310698"/>
            <a:ext cx="6138622" cy="3917279"/>
          </a:xfrm>
          <a:prstGeom prst="rect">
            <a:avLst/>
          </a:prstGeom>
          <a:noFill/>
          <a:ln>
            <a:noFill/>
          </a:ln>
        </p:spPr>
      </p:pic>
      <p:sp>
        <p:nvSpPr>
          <p:cNvPr id="200" name="Google Shape;200;p4"/>
          <p:cNvSpPr txBox="1"/>
          <p:nvPr/>
        </p:nvSpPr>
        <p:spPr>
          <a:xfrm>
            <a:off x="-48903" y="9172603"/>
            <a:ext cx="6906903" cy="7386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4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S5.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ifferential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upled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istribution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f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SVs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t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T</a:t>
            </a:r>
            <a:r>
              <a:rPr lang="it-IT" sz="1400" baseline="-25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0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and T</a:t>
            </a:r>
            <a:r>
              <a:rPr lang="it-IT" sz="1400" baseline="-25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time-points for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ach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sample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t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evel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L5 (Family). The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mparison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ased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n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Kruskal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-Wallis are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ot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tatistically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ignificant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(p&gt;0.05)</a:t>
            </a:r>
            <a:endParaRPr sz="14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201" name="Google Shape;201;p4"/>
          <p:cNvGrpSpPr/>
          <p:nvPr/>
        </p:nvGrpSpPr>
        <p:grpSpPr>
          <a:xfrm>
            <a:off x="541825" y="619126"/>
            <a:ext cx="6316218" cy="4421354"/>
            <a:chOff x="0" y="239843"/>
            <a:chExt cx="6858000" cy="4800601"/>
          </a:xfrm>
        </p:grpSpPr>
        <p:pic>
          <p:nvPicPr>
            <p:cNvPr id="202" name="Google Shape;202;p4" descr="TO_T1_l5.png.png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0" y="239843"/>
              <a:ext cx="6858000" cy="4800601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03" name="Google Shape;203;p4"/>
            <p:cNvSpPr/>
            <p:nvPr/>
          </p:nvSpPr>
          <p:spPr>
            <a:xfrm>
              <a:off x="6071992" y="2627617"/>
              <a:ext cx="760956" cy="1975122"/>
            </a:xfrm>
            <a:prstGeom prst="rect">
              <a:avLst/>
            </a:prstGeom>
            <a:solidFill>
              <a:schemeClr val="lt1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sp>
        <p:nvSpPr>
          <p:cNvPr id="204" name="Google Shape;204;p4"/>
          <p:cNvSpPr txBox="1"/>
          <p:nvPr/>
        </p:nvSpPr>
        <p:spPr>
          <a:xfrm rot="-5400000">
            <a:off x="-1150625" y="625925"/>
            <a:ext cx="3000000" cy="384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3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lative Abundances</a:t>
            </a:r>
            <a:endParaRPr sz="1100"/>
          </a:p>
        </p:txBody>
      </p:sp>
      <p:sp>
        <p:nvSpPr>
          <p:cNvPr id="205" name="Google Shape;205;p4"/>
          <p:cNvSpPr txBox="1"/>
          <p:nvPr/>
        </p:nvSpPr>
        <p:spPr>
          <a:xfrm rot="-5400000">
            <a:off x="-1150625" y="2820425"/>
            <a:ext cx="3000000" cy="384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3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lative Abundances</a:t>
            </a:r>
            <a:endParaRPr sz="110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0" name="Google Shape;210;p5" descr="TO_T1_l6.png_legend.png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779051" y="5150633"/>
            <a:ext cx="4087147" cy="4782440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211" name="Google Shape;211;p5"/>
          <p:cNvGrpSpPr/>
          <p:nvPr/>
        </p:nvGrpSpPr>
        <p:grpSpPr>
          <a:xfrm>
            <a:off x="507847" y="700581"/>
            <a:ext cx="6349994" cy="4444996"/>
            <a:chOff x="86118" y="563671"/>
            <a:chExt cx="6771882" cy="4740318"/>
          </a:xfrm>
        </p:grpSpPr>
        <p:pic>
          <p:nvPicPr>
            <p:cNvPr id="212" name="Google Shape;212;p5" descr="TO_T1_l6.png.png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86118" y="563671"/>
              <a:ext cx="6771882" cy="4740318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13" name="Google Shape;213;p5"/>
            <p:cNvSpPr/>
            <p:nvPr/>
          </p:nvSpPr>
          <p:spPr>
            <a:xfrm>
              <a:off x="6071992" y="2933830"/>
              <a:ext cx="760956" cy="1975122"/>
            </a:xfrm>
            <a:prstGeom prst="rect">
              <a:avLst/>
            </a:prstGeom>
            <a:solidFill>
              <a:schemeClr val="lt1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sp>
        <p:nvSpPr>
          <p:cNvPr id="214" name="Google Shape;214;p5"/>
          <p:cNvSpPr txBox="1"/>
          <p:nvPr/>
        </p:nvSpPr>
        <p:spPr>
          <a:xfrm>
            <a:off x="4733925" y="7934353"/>
            <a:ext cx="2124075" cy="20312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4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S6.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ifferential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upled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istribution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f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SVs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t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T</a:t>
            </a:r>
            <a:r>
              <a:rPr lang="it-IT" sz="1400" baseline="-25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0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and T</a:t>
            </a:r>
            <a:r>
              <a:rPr lang="it-IT" sz="1400" baseline="-25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time-points for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ach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sample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t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evel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L6 (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us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). The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mparison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ased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n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Kruskal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-Wallis are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ot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tatistically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ignificant</a:t>
            </a:r>
            <a:r>
              <a:rPr lang="it-IT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(p&gt;0.05)</a:t>
            </a:r>
            <a:endParaRPr sz="14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5" name="Google Shape;215;p5"/>
          <p:cNvSpPr txBox="1"/>
          <p:nvPr/>
        </p:nvSpPr>
        <p:spPr>
          <a:xfrm rot="-5400000">
            <a:off x="-1148550" y="707400"/>
            <a:ext cx="3000000" cy="384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3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lative Abundances</a:t>
            </a:r>
            <a:endParaRPr sz="1100"/>
          </a:p>
        </p:txBody>
      </p:sp>
      <p:sp>
        <p:nvSpPr>
          <p:cNvPr id="216" name="Google Shape;216;p5"/>
          <p:cNvSpPr txBox="1"/>
          <p:nvPr/>
        </p:nvSpPr>
        <p:spPr>
          <a:xfrm rot="-5400000">
            <a:off x="-1148550" y="2901900"/>
            <a:ext cx="3000000" cy="384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3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lative Abundances</a:t>
            </a:r>
            <a:endParaRPr sz="110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1" name="Google Shape;221;p6"/>
          <p:cNvPicPr preferRelativeResize="0"/>
          <p:nvPr/>
        </p:nvPicPr>
        <p:blipFill rotWithShape="1">
          <a:blip r:embed="rId3">
            <a:alphaModFix/>
          </a:blip>
          <a:srcRect b="17074"/>
          <a:stretch/>
        </p:blipFill>
        <p:spPr>
          <a:xfrm>
            <a:off x="1157100" y="465675"/>
            <a:ext cx="5700903" cy="3979324"/>
          </a:xfrm>
          <a:prstGeom prst="rect">
            <a:avLst/>
          </a:prstGeom>
          <a:noFill/>
          <a:ln>
            <a:noFill/>
          </a:ln>
        </p:spPr>
      </p:pic>
      <p:pic>
        <p:nvPicPr>
          <p:cNvPr id="222" name="Google Shape;222;p6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310286" y="5264339"/>
            <a:ext cx="2417392" cy="1741536"/>
          </a:xfrm>
          <a:prstGeom prst="rect">
            <a:avLst/>
          </a:prstGeom>
          <a:noFill/>
          <a:ln>
            <a:noFill/>
          </a:ln>
        </p:spPr>
      </p:pic>
      <p:sp>
        <p:nvSpPr>
          <p:cNvPr id="223" name="Google Shape;223;p6"/>
          <p:cNvSpPr txBox="1"/>
          <p:nvPr/>
        </p:nvSpPr>
        <p:spPr>
          <a:xfrm>
            <a:off x="68580" y="9167377"/>
            <a:ext cx="678942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4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 S7. ASV </a:t>
            </a:r>
            <a:r>
              <a:rPr lang="it-IT" sz="14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istributions</a:t>
            </a:r>
            <a:r>
              <a:rPr lang="it-IT" sz="14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of </a:t>
            </a:r>
            <a:r>
              <a:rPr lang="it-IT" sz="14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ll</a:t>
            </a:r>
            <a:r>
              <a:rPr lang="it-IT" sz="14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atients</a:t>
            </a:r>
            <a:r>
              <a:rPr lang="it-IT" sz="14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t</a:t>
            </a:r>
            <a:r>
              <a:rPr lang="it-IT" sz="14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T</a:t>
            </a:r>
            <a:r>
              <a:rPr lang="it-IT" sz="1400" baseline="-25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0</a:t>
            </a:r>
            <a:r>
              <a:rPr lang="it-IT" sz="14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nd T</a:t>
            </a:r>
            <a:r>
              <a:rPr lang="it-IT" sz="1400" baseline="-25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</a:t>
            </a:r>
            <a:r>
              <a:rPr lang="it-IT" sz="14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it-IT" sz="14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t</a:t>
            </a:r>
            <a:r>
              <a:rPr lang="it-IT" sz="14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L2 </a:t>
            </a:r>
            <a:r>
              <a:rPr lang="it-IT" sz="14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evel</a:t>
            </a:r>
            <a:r>
              <a:rPr lang="it-IT" sz="14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(phylum). </a:t>
            </a:r>
            <a:r>
              <a:rPr lang="en-US" sz="14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he comparison based on Kruskal-Wallis are not statistically significant (p&gt;0.05)</a:t>
            </a:r>
            <a:endParaRPr dirty="0"/>
          </a:p>
        </p:txBody>
      </p:sp>
      <p:sp>
        <p:nvSpPr>
          <p:cNvPr id="224" name="Google Shape;224;p6"/>
          <p:cNvSpPr txBox="1"/>
          <p:nvPr/>
        </p:nvSpPr>
        <p:spPr>
          <a:xfrm>
            <a:off x="2663500" y="4445000"/>
            <a:ext cx="496800" cy="307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>
                <a:solidFill>
                  <a:schemeClr val="dk1"/>
                </a:solidFill>
              </a:rPr>
              <a:t>T0</a:t>
            </a:r>
            <a:endParaRPr/>
          </a:p>
        </p:txBody>
      </p:sp>
      <p:sp>
        <p:nvSpPr>
          <p:cNvPr id="225" name="Google Shape;225;p6"/>
          <p:cNvSpPr txBox="1"/>
          <p:nvPr/>
        </p:nvSpPr>
        <p:spPr>
          <a:xfrm>
            <a:off x="5248050" y="4445000"/>
            <a:ext cx="496800" cy="307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>
                <a:solidFill>
                  <a:schemeClr val="dk1"/>
                </a:solidFill>
              </a:rPr>
              <a:t>T1</a:t>
            </a:r>
            <a:endParaRPr/>
          </a:p>
        </p:txBody>
      </p:sp>
      <p:sp>
        <p:nvSpPr>
          <p:cNvPr id="226" name="Google Shape;226;p6"/>
          <p:cNvSpPr txBox="1"/>
          <p:nvPr/>
        </p:nvSpPr>
        <p:spPr>
          <a:xfrm rot="-5400000">
            <a:off x="-1435800" y="1992750"/>
            <a:ext cx="4416600" cy="431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lative Abundances of ASV at phylum level</a:t>
            </a:r>
            <a:endParaRPr sz="13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9</TotalTime>
  <Words>318</Words>
  <Application>Microsoft Office PowerPoint</Application>
  <PresentationFormat>A4 (21x29,7 cm)</PresentationFormat>
  <Paragraphs>27</Paragraphs>
  <Slides>7</Slides>
  <Notes>7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7</vt:i4>
      </vt:variant>
    </vt:vector>
  </HeadingPairs>
  <TitlesOfParts>
    <vt:vector size="11" baseType="lpstr">
      <vt:lpstr>Arial</vt:lpstr>
      <vt:lpstr>Noto Sans Symbols</vt:lpstr>
      <vt:lpstr>Calibri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utignani Lorenza</dc:creator>
  <cp:lastModifiedBy>Putignani Lorenza</cp:lastModifiedBy>
  <cp:revision>36</cp:revision>
  <dcterms:created xsi:type="dcterms:W3CDTF">2022-12-12T11:59:21Z</dcterms:created>
  <dcterms:modified xsi:type="dcterms:W3CDTF">2023-03-24T15:48:24Z</dcterms:modified>
</cp:coreProperties>
</file>